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6" r:id="rId2"/>
  </p:sldIdLst>
  <p:sldSz cx="6858000" cy="9906000" type="A4"/>
  <p:notesSz cx="6800850" cy="99329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F00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381" autoAdjust="0"/>
    <p:restoredTop sz="95865" autoAdjust="0"/>
  </p:normalViewPr>
  <p:slideViewPr>
    <p:cSldViewPr snapToGrid="0">
      <p:cViewPr varScale="1">
        <p:scale>
          <a:sx n="66" d="100"/>
          <a:sy n="66" d="100"/>
        </p:scale>
        <p:origin x="287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1625" y="0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r">
              <a:defRPr sz="1200"/>
            </a:lvl1pPr>
          </a:lstStyle>
          <a:p>
            <a:fld id="{D9D91BB7-6D9D-4300-9488-FE6F0B011AF5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62" tIns="46081" rIns="92162" bIns="4608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605" y="4780300"/>
            <a:ext cx="5441642" cy="3910864"/>
          </a:xfrm>
          <a:prstGeom prst="rect">
            <a:avLst/>
          </a:prstGeom>
        </p:spPr>
        <p:txBody>
          <a:bodyPr vert="horz" lIns="92162" tIns="46081" rIns="92162" bIns="4608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34341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1625" y="9434341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r">
              <a:defRPr sz="1200"/>
            </a:lvl1pPr>
          </a:lstStyle>
          <a:p>
            <a:fld id="{1454848C-FEA4-4A2B-87C2-C604F6929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5039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986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974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168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738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206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436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868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3916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421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8854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437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501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548EB3E-7568-F3D9-0AE0-80048A647784}"/>
              </a:ext>
            </a:extLst>
          </p:cNvPr>
          <p:cNvSpPr txBox="1"/>
          <p:nvPr/>
        </p:nvSpPr>
        <p:spPr>
          <a:xfrm>
            <a:off x="3297904" y="64583"/>
            <a:ext cx="38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Table 3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B2529287-9568-AB0F-AA9D-5670F5B8DDA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606482"/>
              </p:ext>
            </p:extLst>
          </p:nvPr>
        </p:nvGraphicFramePr>
        <p:xfrm>
          <a:off x="94488" y="745302"/>
          <a:ext cx="6669025" cy="2510852"/>
        </p:xfrm>
        <a:graphic>
          <a:graphicData uri="http://schemas.openxmlformats.org/drawingml/2006/table">
            <a:tbl>
              <a:tblPr/>
              <a:tblGrid>
                <a:gridCol w="690643">
                  <a:extLst>
                    <a:ext uri="{9D8B030D-6E8A-4147-A177-3AD203B41FA5}">
                      <a16:colId xmlns:a16="http://schemas.microsoft.com/office/drawing/2014/main" val="3804149276"/>
                    </a:ext>
                  </a:extLst>
                </a:gridCol>
                <a:gridCol w="1143878">
                  <a:extLst>
                    <a:ext uri="{9D8B030D-6E8A-4147-A177-3AD203B41FA5}">
                      <a16:colId xmlns:a16="http://schemas.microsoft.com/office/drawing/2014/main" val="366465685"/>
                    </a:ext>
                  </a:extLst>
                </a:gridCol>
                <a:gridCol w="2417252">
                  <a:extLst>
                    <a:ext uri="{9D8B030D-6E8A-4147-A177-3AD203B41FA5}">
                      <a16:colId xmlns:a16="http://schemas.microsoft.com/office/drawing/2014/main" val="4236765281"/>
                    </a:ext>
                  </a:extLst>
                </a:gridCol>
                <a:gridCol w="2417252">
                  <a:extLst>
                    <a:ext uri="{9D8B030D-6E8A-4147-A177-3AD203B41FA5}">
                      <a16:colId xmlns:a16="http://schemas.microsoft.com/office/drawing/2014/main" val="888059023"/>
                    </a:ext>
                  </a:extLst>
                </a:gridCol>
              </a:tblGrid>
              <a:tr h="234448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ene</a:t>
                      </a: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ccession Number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orward Primer (5'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→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')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verse Primer (5'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→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')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7655861"/>
                  </a:ext>
                </a:extLst>
              </a:tr>
              <a:tr h="2268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ampt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M_021524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CAGAAGCCGAGTTCAACATC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TTTCACGGCATTCAAAGTAGGA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6750881"/>
                  </a:ext>
                </a:extLst>
              </a:tr>
              <a:tr h="2268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parg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M_001127330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GAAGACCACTCGCATTCCTT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TAATCAGCAACCATTGGGTCA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7933931"/>
                  </a:ext>
                </a:extLst>
              </a:tr>
              <a:tr h="2268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lin1</a:t>
                      </a: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M_001113471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TGTGTGCAATGCCTATGAGA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TGGAGGGTATTGAAGAGCCG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1511351"/>
                  </a:ext>
                </a:extLst>
              </a:tr>
              <a:tr h="2268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abp4</a:t>
                      </a: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M_024406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AGGTGAAGAGCATCATAACCCT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CACGCCTTTCATAACACATTCC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2948774"/>
                  </a:ext>
                </a:extLst>
              </a:tr>
              <a:tr h="2268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31</a:t>
                      </a: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M_001032378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CGCTGGTGCTCTATGCAAG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CAGTTGCTGCCCATTCATCA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8835274"/>
                  </a:ext>
                </a:extLst>
              </a:tr>
              <a:tr h="2268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ecadherin</a:t>
                      </a: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M_009868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CTGCTTTGGGAGCCTTC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GGGCAGCGATTCATTTTTCT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1931200"/>
                  </a:ext>
                </a:extLst>
              </a:tr>
              <a:tr h="2268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egf</a:t>
                      </a:r>
                      <a:r>
                        <a:rPr lang="el-GR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α</a:t>
                      </a: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USVEGF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CACATAGAGAGAATGAGCTTCC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TCCGCTCTGAACAAGGCT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0797904"/>
                  </a:ext>
                </a:extLst>
              </a:tr>
              <a:tr h="2268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egfr2</a:t>
                      </a: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M_010612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TTGGCAAATACAACCCTTCAGA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CAGAAGATACTGTCACCACC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6404347"/>
                  </a:ext>
                </a:extLst>
              </a:tr>
              <a:tr h="22688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mcn</a:t>
                      </a: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M_016885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CTTTTGTCCAACAGTCTCTGC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ACACGATGCCTGGTATTGTG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30582"/>
                  </a:ext>
                </a:extLst>
              </a:tr>
              <a:tr h="234448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6b4</a:t>
                      </a:r>
                    </a:p>
                  </a:txBody>
                  <a:tcPr marL="5743" marR="5743" marT="574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M_007475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CAGACAACGTGGGCTCCAAGCAGAT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GTCCTCCTTGGTGAACACGAAGCCC</a:t>
                      </a:r>
                    </a:p>
                  </a:txBody>
                  <a:tcPr marL="5743" marR="5743" marT="57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52755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39688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56</TotalTime>
  <Words>81</Words>
  <Application>Microsoft Office PowerPoint</Application>
  <PresentationFormat>A4 210 x 297 mm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 Y</dc:creator>
  <cp:lastModifiedBy>yama1005@keio.jp</cp:lastModifiedBy>
  <cp:revision>511</cp:revision>
  <cp:lastPrinted>2025-08-07T09:30:53Z</cp:lastPrinted>
  <dcterms:created xsi:type="dcterms:W3CDTF">2020-05-07T06:16:48Z</dcterms:created>
  <dcterms:modified xsi:type="dcterms:W3CDTF">2025-09-05T14:08:48Z</dcterms:modified>
</cp:coreProperties>
</file>